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8280400" cy="6227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10" autoAdjust="0"/>
    <p:restoredTop sz="94660"/>
  </p:normalViewPr>
  <p:slideViewPr>
    <p:cSldViewPr snapToGrid="0">
      <p:cViewPr>
        <p:scale>
          <a:sx n="200" d="100"/>
          <a:sy n="200" d="100"/>
        </p:scale>
        <p:origin x="204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0" y="1019220"/>
            <a:ext cx="7038341" cy="2168184"/>
          </a:xfrm>
        </p:spPr>
        <p:txBody>
          <a:bodyPr anchor="b"/>
          <a:lstStyle>
            <a:lvl1pPr algn="ctr">
              <a:defRPr sz="307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35051" y="3271019"/>
            <a:ext cx="6210300" cy="1503600"/>
          </a:xfrm>
        </p:spPr>
        <p:txBody>
          <a:bodyPr/>
          <a:lstStyle>
            <a:lvl1pPr marL="0" indent="0" algn="ctr">
              <a:buNone/>
              <a:defRPr sz="1230"/>
            </a:lvl1pPr>
            <a:lvl2pPr marL="234203" indent="0" algn="ctr">
              <a:buNone/>
              <a:defRPr sz="1024"/>
            </a:lvl2pPr>
            <a:lvl3pPr marL="468406" indent="0" algn="ctr">
              <a:buNone/>
              <a:defRPr sz="922"/>
            </a:lvl3pPr>
            <a:lvl4pPr marL="702610" indent="0" algn="ctr">
              <a:buNone/>
              <a:defRPr sz="820"/>
            </a:lvl4pPr>
            <a:lvl5pPr marL="936813" indent="0" algn="ctr">
              <a:buNone/>
              <a:defRPr sz="820"/>
            </a:lvl5pPr>
            <a:lvl6pPr marL="1171016" indent="0" algn="ctr">
              <a:buNone/>
              <a:defRPr sz="820"/>
            </a:lvl6pPr>
            <a:lvl7pPr marL="1405219" indent="0" algn="ctr">
              <a:buNone/>
              <a:defRPr sz="820"/>
            </a:lvl7pPr>
            <a:lvl8pPr marL="1639422" indent="0" algn="ctr">
              <a:buNone/>
              <a:defRPr sz="820"/>
            </a:lvl8pPr>
            <a:lvl9pPr marL="1873625" indent="0" algn="ctr">
              <a:buNone/>
              <a:defRPr sz="82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5040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8173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925662" y="331571"/>
            <a:ext cx="1785461" cy="5277741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9278" y="331571"/>
            <a:ext cx="5252879" cy="5277741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6456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8722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4964" y="1552618"/>
            <a:ext cx="7141846" cy="2590576"/>
          </a:xfrm>
        </p:spPr>
        <p:txBody>
          <a:bodyPr anchor="b"/>
          <a:lstStyle>
            <a:lvl1pPr>
              <a:defRPr sz="307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4964" y="4167701"/>
            <a:ext cx="7141846" cy="1362323"/>
          </a:xfrm>
        </p:spPr>
        <p:txBody>
          <a:bodyPr/>
          <a:lstStyle>
            <a:lvl1pPr marL="0" indent="0">
              <a:buNone/>
              <a:defRPr sz="1230">
                <a:solidFill>
                  <a:schemeClr val="tx1"/>
                </a:solidFill>
              </a:defRPr>
            </a:lvl1pPr>
            <a:lvl2pPr marL="234203" indent="0">
              <a:buNone/>
              <a:defRPr sz="1024">
                <a:solidFill>
                  <a:schemeClr val="tx1">
                    <a:tint val="75000"/>
                  </a:schemeClr>
                </a:solidFill>
              </a:defRPr>
            </a:lvl2pPr>
            <a:lvl3pPr marL="468406" indent="0">
              <a:buNone/>
              <a:defRPr sz="922">
                <a:solidFill>
                  <a:schemeClr val="tx1">
                    <a:tint val="75000"/>
                  </a:schemeClr>
                </a:solidFill>
              </a:defRPr>
            </a:lvl3pPr>
            <a:lvl4pPr marL="702610" indent="0">
              <a:buNone/>
              <a:defRPr sz="820">
                <a:solidFill>
                  <a:schemeClr val="tx1">
                    <a:tint val="75000"/>
                  </a:schemeClr>
                </a:solidFill>
              </a:defRPr>
            </a:lvl4pPr>
            <a:lvl5pPr marL="936813" indent="0">
              <a:buNone/>
              <a:defRPr sz="820">
                <a:solidFill>
                  <a:schemeClr val="tx1">
                    <a:tint val="75000"/>
                  </a:schemeClr>
                </a:solidFill>
              </a:defRPr>
            </a:lvl5pPr>
            <a:lvl6pPr marL="1171016" indent="0">
              <a:buNone/>
              <a:defRPr sz="820">
                <a:solidFill>
                  <a:schemeClr val="tx1">
                    <a:tint val="75000"/>
                  </a:schemeClr>
                </a:solidFill>
              </a:defRPr>
            </a:lvl6pPr>
            <a:lvl7pPr marL="1405219" indent="0">
              <a:buNone/>
              <a:defRPr sz="820">
                <a:solidFill>
                  <a:schemeClr val="tx1">
                    <a:tint val="75000"/>
                  </a:schemeClr>
                </a:solidFill>
              </a:defRPr>
            </a:lvl7pPr>
            <a:lvl8pPr marL="1639422" indent="0">
              <a:buNone/>
              <a:defRPr sz="820">
                <a:solidFill>
                  <a:schemeClr val="tx1">
                    <a:tint val="75000"/>
                  </a:schemeClr>
                </a:solidFill>
              </a:defRPr>
            </a:lvl8pPr>
            <a:lvl9pPr marL="1873625" indent="0">
              <a:buNone/>
              <a:defRPr sz="8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0078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9278" y="1657853"/>
            <a:ext cx="3519170" cy="395145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91953" y="1657853"/>
            <a:ext cx="3519170" cy="395145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2880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331572"/>
            <a:ext cx="7141846" cy="120374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0358" y="1526668"/>
            <a:ext cx="3502996" cy="748196"/>
          </a:xfrm>
        </p:spPr>
        <p:txBody>
          <a:bodyPr anchor="b"/>
          <a:lstStyle>
            <a:lvl1pPr marL="0" indent="0">
              <a:buNone/>
              <a:defRPr sz="1230" b="1"/>
            </a:lvl1pPr>
            <a:lvl2pPr marL="234203" indent="0">
              <a:buNone/>
              <a:defRPr sz="1024" b="1"/>
            </a:lvl2pPr>
            <a:lvl3pPr marL="468406" indent="0">
              <a:buNone/>
              <a:defRPr sz="922" b="1"/>
            </a:lvl3pPr>
            <a:lvl4pPr marL="702610" indent="0">
              <a:buNone/>
              <a:defRPr sz="820" b="1"/>
            </a:lvl4pPr>
            <a:lvl5pPr marL="936813" indent="0">
              <a:buNone/>
              <a:defRPr sz="820" b="1"/>
            </a:lvl5pPr>
            <a:lvl6pPr marL="1171016" indent="0">
              <a:buNone/>
              <a:defRPr sz="820" b="1"/>
            </a:lvl6pPr>
            <a:lvl7pPr marL="1405219" indent="0">
              <a:buNone/>
              <a:defRPr sz="820" b="1"/>
            </a:lvl7pPr>
            <a:lvl8pPr marL="1639422" indent="0">
              <a:buNone/>
              <a:defRPr sz="820" b="1"/>
            </a:lvl8pPr>
            <a:lvl9pPr marL="1873625" indent="0">
              <a:buNone/>
              <a:defRPr sz="82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0358" y="2274864"/>
            <a:ext cx="3502996" cy="334598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91954" y="1526668"/>
            <a:ext cx="3520248" cy="748196"/>
          </a:xfrm>
        </p:spPr>
        <p:txBody>
          <a:bodyPr anchor="b"/>
          <a:lstStyle>
            <a:lvl1pPr marL="0" indent="0">
              <a:buNone/>
              <a:defRPr sz="1230" b="1"/>
            </a:lvl1pPr>
            <a:lvl2pPr marL="234203" indent="0">
              <a:buNone/>
              <a:defRPr sz="1024" b="1"/>
            </a:lvl2pPr>
            <a:lvl3pPr marL="468406" indent="0">
              <a:buNone/>
              <a:defRPr sz="922" b="1"/>
            </a:lvl3pPr>
            <a:lvl4pPr marL="702610" indent="0">
              <a:buNone/>
              <a:defRPr sz="820" b="1"/>
            </a:lvl4pPr>
            <a:lvl5pPr marL="936813" indent="0">
              <a:buNone/>
              <a:defRPr sz="820" b="1"/>
            </a:lvl5pPr>
            <a:lvl6pPr marL="1171016" indent="0">
              <a:buNone/>
              <a:defRPr sz="820" b="1"/>
            </a:lvl6pPr>
            <a:lvl7pPr marL="1405219" indent="0">
              <a:buNone/>
              <a:defRPr sz="820" b="1"/>
            </a:lvl7pPr>
            <a:lvl8pPr marL="1639422" indent="0">
              <a:buNone/>
              <a:defRPr sz="820" b="1"/>
            </a:lvl8pPr>
            <a:lvl9pPr marL="1873625" indent="0">
              <a:buNone/>
              <a:defRPr sz="82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91954" y="2274864"/>
            <a:ext cx="3520248" cy="334598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7069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2150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5132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415185"/>
            <a:ext cx="2670645" cy="1453144"/>
          </a:xfrm>
        </p:spPr>
        <p:txBody>
          <a:bodyPr anchor="b"/>
          <a:lstStyle>
            <a:lvl1pPr>
              <a:defRPr sz="164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20249" y="896684"/>
            <a:ext cx="4191952" cy="4425748"/>
          </a:xfrm>
        </p:spPr>
        <p:txBody>
          <a:bodyPr/>
          <a:lstStyle>
            <a:lvl1pPr>
              <a:defRPr sz="1640"/>
            </a:lvl1pPr>
            <a:lvl2pPr>
              <a:defRPr sz="1434"/>
            </a:lvl2pPr>
            <a:lvl3pPr>
              <a:defRPr sz="1230"/>
            </a:lvl3pPr>
            <a:lvl4pPr>
              <a:defRPr sz="1024"/>
            </a:lvl4pPr>
            <a:lvl5pPr>
              <a:defRPr sz="1024"/>
            </a:lvl5pPr>
            <a:lvl6pPr>
              <a:defRPr sz="1024"/>
            </a:lvl6pPr>
            <a:lvl7pPr>
              <a:defRPr sz="1024"/>
            </a:lvl7pPr>
            <a:lvl8pPr>
              <a:defRPr sz="1024"/>
            </a:lvl8pPr>
            <a:lvl9pPr>
              <a:defRPr sz="1024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1868329"/>
            <a:ext cx="2670645" cy="3461311"/>
          </a:xfrm>
        </p:spPr>
        <p:txBody>
          <a:bodyPr/>
          <a:lstStyle>
            <a:lvl1pPr marL="0" indent="0">
              <a:buNone/>
              <a:defRPr sz="820"/>
            </a:lvl1pPr>
            <a:lvl2pPr marL="234203" indent="0">
              <a:buNone/>
              <a:defRPr sz="718"/>
            </a:lvl2pPr>
            <a:lvl3pPr marL="468406" indent="0">
              <a:buNone/>
              <a:defRPr sz="614"/>
            </a:lvl3pPr>
            <a:lvl4pPr marL="702610" indent="0">
              <a:buNone/>
              <a:defRPr sz="512"/>
            </a:lvl4pPr>
            <a:lvl5pPr marL="936813" indent="0">
              <a:buNone/>
              <a:defRPr sz="512"/>
            </a:lvl5pPr>
            <a:lvl6pPr marL="1171016" indent="0">
              <a:buNone/>
              <a:defRPr sz="512"/>
            </a:lvl6pPr>
            <a:lvl7pPr marL="1405219" indent="0">
              <a:buNone/>
              <a:defRPr sz="512"/>
            </a:lvl7pPr>
            <a:lvl8pPr marL="1639422" indent="0">
              <a:buNone/>
              <a:defRPr sz="512"/>
            </a:lvl8pPr>
            <a:lvl9pPr marL="1873625" indent="0">
              <a:buNone/>
              <a:defRPr sz="512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788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415185"/>
            <a:ext cx="2670645" cy="1453144"/>
          </a:xfrm>
        </p:spPr>
        <p:txBody>
          <a:bodyPr anchor="b"/>
          <a:lstStyle>
            <a:lvl1pPr>
              <a:defRPr sz="164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20249" y="896684"/>
            <a:ext cx="4191952" cy="4425748"/>
          </a:xfrm>
        </p:spPr>
        <p:txBody>
          <a:bodyPr anchor="t"/>
          <a:lstStyle>
            <a:lvl1pPr marL="0" indent="0">
              <a:buNone/>
              <a:defRPr sz="1640"/>
            </a:lvl1pPr>
            <a:lvl2pPr marL="234203" indent="0">
              <a:buNone/>
              <a:defRPr sz="1434"/>
            </a:lvl2pPr>
            <a:lvl3pPr marL="468406" indent="0">
              <a:buNone/>
              <a:defRPr sz="1230"/>
            </a:lvl3pPr>
            <a:lvl4pPr marL="702610" indent="0">
              <a:buNone/>
              <a:defRPr sz="1024"/>
            </a:lvl4pPr>
            <a:lvl5pPr marL="936813" indent="0">
              <a:buNone/>
              <a:defRPr sz="1024"/>
            </a:lvl5pPr>
            <a:lvl6pPr marL="1171016" indent="0">
              <a:buNone/>
              <a:defRPr sz="1024"/>
            </a:lvl6pPr>
            <a:lvl7pPr marL="1405219" indent="0">
              <a:buNone/>
              <a:defRPr sz="1024"/>
            </a:lvl7pPr>
            <a:lvl8pPr marL="1639422" indent="0">
              <a:buNone/>
              <a:defRPr sz="1024"/>
            </a:lvl8pPr>
            <a:lvl9pPr marL="1873625" indent="0">
              <a:buNone/>
              <a:defRPr sz="1024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1868329"/>
            <a:ext cx="2670645" cy="3461311"/>
          </a:xfrm>
        </p:spPr>
        <p:txBody>
          <a:bodyPr/>
          <a:lstStyle>
            <a:lvl1pPr marL="0" indent="0">
              <a:buNone/>
              <a:defRPr sz="820"/>
            </a:lvl1pPr>
            <a:lvl2pPr marL="234203" indent="0">
              <a:buNone/>
              <a:defRPr sz="718"/>
            </a:lvl2pPr>
            <a:lvl3pPr marL="468406" indent="0">
              <a:buNone/>
              <a:defRPr sz="614"/>
            </a:lvl3pPr>
            <a:lvl4pPr marL="702610" indent="0">
              <a:buNone/>
              <a:defRPr sz="512"/>
            </a:lvl4pPr>
            <a:lvl5pPr marL="936813" indent="0">
              <a:buNone/>
              <a:defRPr sz="512"/>
            </a:lvl5pPr>
            <a:lvl6pPr marL="1171016" indent="0">
              <a:buNone/>
              <a:defRPr sz="512"/>
            </a:lvl6pPr>
            <a:lvl7pPr marL="1405219" indent="0">
              <a:buNone/>
              <a:defRPr sz="512"/>
            </a:lvl7pPr>
            <a:lvl8pPr marL="1639422" indent="0">
              <a:buNone/>
              <a:defRPr sz="512"/>
            </a:lvl8pPr>
            <a:lvl9pPr marL="1873625" indent="0">
              <a:buNone/>
              <a:defRPr sz="512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4947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9278" y="331572"/>
            <a:ext cx="7141846" cy="120374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9278" y="1657853"/>
            <a:ext cx="7141846" cy="39514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9279" y="5772215"/>
            <a:ext cx="1863090" cy="3315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E77FBC-A8AA-4A70-A103-82E6F882323B}" type="datetimeFigureOut">
              <a:rPr lang="fr-FR" smtClean="0"/>
              <a:t>1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42883" y="5772215"/>
            <a:ext cx="2794635" cy="3315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48033" y="5772215"/>
            <a:ext cx="1863090" cy="3315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1090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468406" rtl="0" eaLnBrk="1" latinLnBrk="0" hangingPunct="1">
        <a:lnSpc>
          <a:spcPct val="90000"/>
        </a:lnSpc>
        <a:spcBef>
          <a:spcPct val="0"/>
        </a:spcBef>
        <a:buNone/>
        <a:defRPr sz="225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7101" indent="-117101" algn="l" defTabSz="468406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434" kern="1200">
          <a:solidFill>
            <a:schemeClr val="tx1"/>
          </a:solidFill>
          <a:latin typeface="+mn-lt"/>
          <a:ea typeface="+mn-ea"/>
          <a:cs typeface="+mn-cs"/>
        </a:defRPr>
      </a:lvl1pPr>
      <a:lvl2pPr marL="351304" indent="-117101" algn="l" defTabSz="468406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1230" kern="1200">
          <a:solidFill>
            <a:schemeClr val="tx1"/>
          </a:solidFill>
          <a:latin typeface="+mn-lt"/>
          <a:ea typeface="+mn-ea"/>
          <a:cs typeface="+mn-cs"/>
        </a:defRPr>
      </a:lvl2pPr>
      <a:lvl3pPr marL="585508" indent="-117101" algn="l" defTabSz="468406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1024" kern="1200">
          <a:solidFill>
            <a:schemeClr val="tx1"/>
          </a:solidFill>
          <a:latin typeface="+mn-lt"/>
          <a:ea typeface="+mn-ea"/>
          <a:cs typeface="+mn-cs"/>
        </a:defRPr>
      </a:lvl3pPr>
      <a:lvl4pPr marL="819711" indent="-117101" algn="l" defTabSz="468406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2" kern="1200">
          <a:solidFill>
            <a:schemeClr val="tx1"/>
          </a:solidFill>
          <a:latin typeface="+mn-lt"/>
          <a:ea typeface="+mn-ea"/>
          <a:cs typeface="+mn-cs"/>
        </a:defRPr>
      </a:lvl4pPr>
      <a:lvl5pPr marL="1053914" indent="-117101" algn="l" defTabSz="468406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2" kern="1200">
          <a:solidFill>
            <a:schemeClr val="tx1"/>
          </a:solidFill>
          <a:latin typeface="+mn-lt"/>
          <a:ea typeface="+mn-ea"/>
          <a:cs typeface="+mn-cs"/>
        </a:defRPr>
      </a:lvl5pPr>
      <a:lvl6pPr marL="1288117" indent="-117101" algn="l" defTabSz="468406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2" kern="1200">
          <a:solidFill>
            <a:schemeClr val="tx1"/>
          </a:solidFill>
          <a:latin typeface="+mn-lt"/>
          <a:ea typeface="+mn-ea"/>
          <a:cs typeface="+mn-cs"/>
        </a:defRPr>
      </a:lvl6pPr>
      <a:lvl7pPr marL="1522320" indent="-117101" algn="l" defTabSz="468406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2" kern="1200">
          <a:solidFill>
            <a:schemeClr val="tx1"/>
          </a:solidFill>
          <a:latin typeface="+mn-lt"/>
          <a:ea typeface="+mn-ea"/>
          <a:cs typeface="+mn-cs"/>
        </a:defRPr>
      </a:lvl7pPr>
      <a:lvl8pPr marL="1756524" indent="-117101" algn="l" defTabSz="468406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2" kern="1200">
          <a:solidFill>
            <a:schemeClr val="tx1"/>
          </a:solidFill>
          <a:latin typeface="+mn-lt"/>
          <a:ea typeface="+mn-ea"/>
          <a:cs typeface="+mn-cs"/>
        </a:defRPr>
      </a:lvl8pPr>
      <a:lvl9pPr marL="1990727" indent="-117101" algn="l" defTabSz="468406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68406" rtl="0" eaLnBrk="1" latinLnBrk="0" hangingPunct="1">
        <a:defRPr sz="922" kern="1200">
          <a:solidFill>
            <a:schemeClr val="tx1"/>
          </a:solidFill>
          <a:latin typeface="+mn-lt"/>
          <a:ea typeface="+mn-ea"/>
          <a:cs typeface="+mn-cs"/>
        </a:defRPr>
      </a:lvl1pPr>
      <a:lvl2pPr marL="234203" algn="l" defTabSz="468406" rtl="0" eaLnBrk="1" latinLnBrk="0" hangingPunct="1">
        <a:defRPr sz="922" kern="1200">
          <a:solidFill>
            <a:schemeClr val="tx1"/>
          </a:solidFill>
          <a:latin typeface="+mn-lt"/>
          <a:ea typeface="+mn-ea"/>
          <a:cs typeface="+mn-cs"/>
        </a:defRPr>
      </a:lvl2pPr>
      <a:lvl3pPr marL="468406" algn="l" defTabSz="468406" rtl="0" eaLnBrk="1" latinLnBrk="0" hangingPunct="1">
        <a:defRPr sz="922" kern="1200">
          <a:solidFill>
            <a:schemeClr val="tx1"/>
          </a:solidFill>
          <a:latin typeface="+mn-lt"/>
          <a:ea typeface="+mn-ea"/>
          <a:cs typeface="+mn-cs"/>
        </a:defRPr>
      </a:lvl3pPr>
      <a:lvl4pPr marL="702610" algn="l" defTabSz="468406" rtl="0" eaLnBrk="1" latinLnBrk="0" hangingPunct="1">
        <a:defRPr sz="922" kern="1200">
          <a:solidFill>
            <a:schemeClr val="tx1"/>
          </a:solidFill>
          <a:latin typeface="+mn-lt"/>
          <a:ea typeface="+mn-ea"/>
          <a:cs typeface="+mn-cs"/>
        </a:defRPr>
      </a:lvl4pPr>
      <a:lvl5pPr marL="936813" algn="l" defTabSz="468406" rtl="0" eaLnBrk="1" latinLnBrk="0" hangingPunct="1">
        <a:defRPr sz="922" kern="1200">
          <a:solidFill>
            <a:schemeClr val="tx1"/>
          </a:solidFill>
          <a:latin typeface="+mn-lt"/>
          <a:ea typeface="+mn-ea"/>
          <a:cs typeface="+mn-cs"/>
        </a:defRPr>
      </a:lvl5pPr>
      <a:lvl6pPr marL="1171016" algn="l" defTabSz="468406" rtl="0" eaLnBrk="1" latinLnBrk="0" hangingPunct="1">
        <a:defRPr sz="922" kern="1200">
          <a:solidFill>
            <a:schemeClr val="tx1"/>
          </a:solidFill>
          <a:latin typeface="+mn-lt"/>
          <a:ea typeface="+mn-ea"/>
          <a:cs typeface="+mn-cs"/>
        </a:defRPr>
      </a:lvl6pPr>
      <a:lvl7pPr marL="1405219" algn="l" defTabSz="468406" rtl="0" eaLnBrk="1" latinLnBrk="0" hangingPunct="1">
        <a:defRPr sz="922" kern="1200">
          <a:solidFill>
            <a:schemeClr val="tx1"/>
          </a:solidFill>
          <a:latin typeface="+mn-lt"/>
          <a:ea typeface="+mn-ea"/>
          <a:cs typeface="+mn-cs"/>
        </a:defRPr>
      </a:lvl7pPr>
      <a:lvl8pPr marL="1639422" algn="l" defTabSz="468406" rtl="0" eaLnBrk="1" latinLnBrk="0" hangingPunct="1">
        <a:defRPr sz="922" kern="1200">
          <a:solidFill>
            <a:schemeClr val="tx1"/>
          </a:solidFill>
          <a:latin typeface="+mn-lt"/>
          <a:ea typeface="+mn-ea"/>
          <a:cs typeface="+mn-cs"/>
        </a:defRPr>
      </a:lvl8pPr>
      <a:lvl9pPr marL="1873625" algn="l" defTabSz="468406" rtl="0" eaLnBrk="1" latinLnBrk="0" hangingPunct="1">
        <a:defRPr sz="92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Groupe 64"/>
          <p:cNvGrpSpPr>
            <a:grpSpLocks noChangeAspect="1"/>
          </p:cNvGrpSpPr>
          <p:nvPr/>
        </p:nvGrpSpPr>
        <p:grpSpPr>
          <a:xfrm>
            <a:off x="0" y="337198"/>
            <a:ext cx="8280000" cy="4958554"/>
            <a:chOff x="0" y="337198"/>
            <a:chExt cx="8938997" cy="5353200"/>
          </a:xfrm>
        </p:grpSpPr>
        <p:grpSp>
          <p:nvGrpSpPr>
            <p:cNvPr id="2" name="Groupe 1"/>
            <p:cNvGrpSpPr/>
            <p:nvPr/>
          </p:nvGrpSpPr>
          <p:grpSpPr>
            <a:xfrm>
              <a:off x="4606850" y="337198"/>
              <a:ext cx="4332147" cy="5353200"/>
              <a:chOff x="2171008" y="1230100"/>
              <a:chExt cx="5760000" cy="7202080"/>
            </a:xfrm>
          </p:grpSpPr>
          <p:pic>
            <p:nvPicPr>
              <p:cNvPr id="3" name="Image 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171008" y="4112180"/>
                <a:ext cx="1440000" cy="14400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4" name="Image 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611008" y="555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5" name="Image 4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611008" y="699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6" name="Image 5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611008" y="411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7" name="Image 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051008" y="555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8" name="Image 7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051008" y="699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9" name="Image 8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051008" y="411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10" name="Image 9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491008" y="555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11" name="Image 10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491008" y="411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12" name="Image 11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171008" y="699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13" name="Image 12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491008" y="6992180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14" name="Image 13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171008" y="5552180"/>
                <a:ext cx="1440000" cy="1440000"/>
              </a:xfrm>
              <a:prstGeom prst="rect">
                <a:avLst/>
              </a:prstGeom>
            </p:spPr>
          </p:pic>
          <p:grpSp>
            <p:nvGrpSpPr>
              <p:cNvPr id="15" name="Groupe 14"/>
              <p:cNvGrpSpPr/>
              <p:nvPr/>
            </p:nvGrpSpPr>
            <p:grpSpPr>
              <a:xfrm>
                <a:off x="6491008" y="2442063"/>
                <a:ext cx="1440000" cy="1670117"/>
                <a:chOff x="11500073" y="8049807"/>
                <a:chExt cx="1440000" cy="1670117"/>
              </a:xfrm>
            </p:grpSpPr>
            <p:pic>
              <p:nvPicPr>
                <p:cNvPr id="32" name="Image 31"/>
                <p:cNvPicPr>
                  <a:picLocks noChangeAspect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500073" y="8279924"/>
                  <a:ext cx="1440000" cy="1440000"/>
                </a:xfrm>
                <a:prstGeom prst="rect">
                  <a:avLst/>
                </a:prstGeom>
              </p:spPr>
            </p:pic>
            <p:sp>
              <p:nvSpPr>
                <p:cNvPr id="33" name="ZoneTexte 32"/>
                <p:cNvSpPr txBox="1"/>
                <p:nvPr/>
              </p:nvSpPr>
              <p:spPr>
                <a:xfrm>
                  <a:off x="11795714" y="8049807"/>
                  <a:ext cx="819622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/>
                    <a:t>Manang</a:t>
                  </a:r>
                </a:p>
                <a:p>
                  <a:pPr algn="ctr"/>
                  <a:r>
                    <a:rPr lang="en-US" sz="800" i="1" dirty="0"/>
                    <a:t>hybrid</a:t>
                  </a:r>
                </a:p>
              </p:txBody>
            </p:sp>
          </p:grpSp>
          <p:grpSp>
            <p:nvGrpSpPr>
              <p:cNvPr id="16" name="Groupe 15"/>
              <p:cNvGrpSpPr/>
              <p:nvPr/>
            </p:nvGrpSpPr>
            <p:grpSpPr>
              <a:xfrm>
                <a:off x="2171008" y="1230100"/>
                <a:ext cx="2880000" cy="2882080"/>
                <a:chOff x="7104889" y="7115947"/>
                <a:chExt cx="2880000" cy="2882080"/>
              </a:xfrm>
            </p:grpSpPr>
            <p:pic>
              <p:nvPicPr>
                <p:cNvPr id="30" name="Image 29"/>
                <p:cNvPicPr>
                  <a:picLocks noChangeAspect="1"/>
                </p:cNvPicPr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104889" y="7118027"/>
                  <a:ext cx="2880000" cy="2880000"/>
                </a:xfrm>
                <a:prstGeom prst="rect">
                  <a:avLst/>
                </a:prstGeom>
              </p:spPr>
            </p:pic>
            <p:sp>
              <p:nvSpPr>
                <p:cNvPr id="31" name="ZoneTexte 30"/>
                <p:cNvSpPr txBox="1"/>
                <p:nvPr/>
              </p:nvSpPr>
              <p:spPr>
                <a:xfrm>
                  <a:off x="7775385" y="7115947"/>
                  <a:ext cx="1557574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/>
                    <a:t>Calcutta4</a:t>
                  </a:r>
                </a:p>
                <a:p>
                  <a:pPr algn="ctr"/>
                  <a:r>
                    <a:rPr lang="en-US" sz="800" i="1" dirty="0"/>
                    <a:t>Ssp </a:t>
                  </a:r>
                  <a:r>
                    <a:rPr lang="en-US" sz="800" i="1" dirty="0" err="1"/>
                    <a:t>burmannicoides</a:t>
                  </a:r>
                  <a:endParaRPr lang="en-US" sz="800" i="1" dirty="0"/>
                </a:p>
              </p:txBody>
            </p:sp>
          </p:grpSp>
          <p:grpSp>
            <p:nvGrpSpPr>
              <p:cNvPr id="17" name="Groupe 16"/>
              <p:cNvGrpSpPr/>
              <p:nvPr/>
            </p:nvGrpSpPr>
            <p:grpSpPr>
              <a:xfrm>
                <a:off x="2214305" y="3874719"/>
                <a:ext cx="5700109" cy="3384990"/>
                <a:chOff x="6307924" y="5994207"/>
                <a:chExt cx="5700109" cy="3384990"/>
              </a:xfrm>
            </p:grpSpPr>
            <p:sp>
              <p:nvSpPr>
                <p:cNvPr id="18" name="ZoneTexte 17"/>
                <p:cNvSpPr txBox="1"/>
                <p:nvPr/>
              </p:nvSpPr>
              <p:spPr>
                <a:xfrm>
                  <a:off x="6307924" y="6009347"/>
                  <a:ext cx="1350305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 err="1"/>
                    <a:t>Akondro</a:t>
                  </a:r>
                  <a:r>
                    <a:rPr lang="en-US" sz="800" b="1" dirty="0"/>
                    <a:t> </a:t>
                  </a:r>
                  <a:r>
                    <a:rPr lang="en-US" sz="800" b="1" dirty="0" err="1"/>
                    <a:t>Mainty</a:t>
                  </a:r>
                  <a:endParaRPr lang="en-US" sz="800" b="1" dirty="0"/>
                </a:p>
                <a:p>
                  <a:pPr algn="ctr"/>
                  <a:r>
                    <a:rPr lang="en-US" sz="800" i="1" dirty="0"/>
                    <a:t>hybrid</a:t>
                  </a:r>
                </a:p>
              </p:txBody>
            </p:sp>
            <p:sp>
              <p:nvSpPr>
                <p:cNvPr id="19" name="ZoneTexte 18"/>
                <p:cNvSpPr txBox="1"/>
                <p:nvPr/>
              </p:nvSpPr>
              <p:spPr>
                <a:xfrm>
                  <a:off x="7909666" y="7448310"/>
                  <a:ext cx="1011490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 err="1"/>
                    <a:t>Banksii</a:t>
                  </a:r>
                  <a:endParaRPr lang="en-US" sz="800" b="1" dirty="0"/>
                </a:p>
                <a:p>
                  <a:pPr algn="ctr"/>
                  <a:r>
                    <a:rPr lang="en-US" sz="800" i="1" dirty="0"/>
                    <a:t>ssp. </a:t>
                  </a:r>
                  <a:r>
                    <a:rPr lang="en-US" sz="800" i="1" dirty="0" err="1"/>
                    <a:t>banksii</a:t>
                  </a:r>
                  <a:endParaRPr lang="en-US" sz="800" i="1" dirty="0"/>
                </a:p>
              </p:txBody>
            </p:sp>
            <p:sp>
              <p:nvSpPr>
                <p:cNvPr id="20" name="ZoneTexte 19"/>
                <p:cNvSpPr txBox="1"/>
                <p:nvPr/>
              </p:nvSpPr>
              <p:spPr>
                <a:xfrm>
                  <a:off x="7779659" y="8885214"/>
                  <a:ext cx="1289451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/>
                    <a:t>Borneo</a:t>
                  </a:r>
                </a:p>
                <a:p>
                  <a:pPr algn="ctr"/>
                  <a:r>
                    <a:rPr lang="en-US" sz="800" i="1" dirty="0"/>
                    <a:t>ssp. </a:t>
                  </a:r>
                  <a:r>
                    <a:rPr lang="en-US" sz="800" i="1" dirty="0" err="1"/>
                    <a:t>microcarpa</a:t>
                  </a:r>
                  <a:endParaRPr lang="en-US" sz="800" i="1" dirty="0"/>
                </a:p>
              </p:txBody>
            </p:sp>
            <p:sp>
              <p:nvSpPr>
                <p:cNvPr id="21" name="ZoneTexte 20"/>
                <p:cNvSpPr txBox="1"/>
                <p:nvPr/>
              </p:nvSpPr>
              <p:spPr>
                <a:xfrm>
                  <a:off x="8066308" y="6009347"/>
                  <a:ext cx="676570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 err="1"/>
                    <a:t>Galeo</a:t>
                  </a:r>
                  <a:endParaRPr lang="en-US" sz="800" b="1" dirty="0"/>
                </a:p>
                <a:p>
                  <a:pPr algn="ctr"/>
                  <a:r>
                    <a:rPr lang="en-US" sz="800" i="1" dirty="0"/>
                    <a:t>hybrid</a:t>
                  </a:r>
                </a:p>
              </p:txBody>
            </p:sp>
            <p:sp>
              <p:nvSpPr>
                <p:cNvPr id="22" name="ZoneTexte 21"/>
                <p:cNvSpPr txBox="1"/>
                <p:nvPr/>
              </p:nvSpPr>
              <p:spPr>
                <a:xfrm>
                  <a:off x="9269948" y="7448310"/>
                  <a:ext cx="1164741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/>
                    <a:t>Grande </a:t>
                  </a:r>
                  <a:r>
                    <a:rPr lang="en-US" sz="800" b="1" dirty="0" err="1"/>
                    <a:t>Naine</a:t>
                  </a:r>
                  <a:endParaRPr lang="en-US" sz="800" b="1" dirty="0"/>
                </a:p>
                <a:p>
                  <a:pPr algn="ctr"/>
                  <a:r>
                    <a:rPr lang="en-US" sz="800" i="1" dirty="0"/>
                    <a:t>triploid hybrid</a:t>
                  </a:r>
                </a:p>
              </p:txBody>
            </p:sp>
            <p:sp>
              <p:nvSpPr>
                <p:cNvPr id="23" name="ZoneTexte 22"/>
                <p:cNvSpPr txBox="1"/>
                <p:nvPr/>
              </p:nvSpPr>
              <p:spPr>
                <a:xfrm>
                  <a:off x="9462666" y="8885214"/>
                  <a:ext cx="752695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/>
                    <a:t>IDN110</a:t>
                  </a:r>
                </a:p>
                <a:p>
                  <a:pPr algn="ctr"/>
                  <a:r>
                    <a:rPr lang="en-US" sz="800" i="1" dirty="0"/>
                    <a:t>hybrid</a:t>
                  </a:r>
                </a:p>
              </p:txBody>
            </p:sp>
            <p:sp>
              <p:nvSpPr>
                <p:cNvPr id="24" name="ZoneTexte 23"/>
                <p:cNvSpPr txBox="1"/>
                <p:nvPr/>
              </p:nvSpPr>
              <p:spPr>
                <a:xfrm>
                  <a:off x="9336034" y="6009347"/>
                  <a:ext cx="1033629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/>
                    <a:t>Maia </a:t>
                  </a:r>
                  <a:r>
                    <a:rPr lang="en-US" sz="800" b="1" dirty="0" err="1"/>
                    <a:t>Oa</a:t>
                  </a:r>
                  <a:endParaRPr lang="en-US" sz="800" b="1" dirty="0"/>
                </a:p>
                <a:p>
                  <a:pPr algn="ctr"/>
                  <a:r>
                    <a:rPr lang="en-US" sz="800" i="1" dirty="0"/>
                    <a:t>ssp. </a:t>
                  </a:r>
                  <a:r>
                    <a:rPr lang="en-US" sz="800" i="1" dirty="0" err="1"/>
                    <a:t>zebrina</a:t>
                  </a:r>
                  <a:endParaRPr lang="en-US" sz="800" i="1" dirty="0"/>
                </a:p>
              </p:txBody>
            </p:sp>
            <p:sp>
              <p:nvSpPr>
                <p:cNvPr id="25" name="ZoneTexte 24"/>
                <p:cNvSpPr txBox="1"/>
                <p:nvPr/>
              </p:nvSpPr>
              <p:spPr>
                <a:xfrm>
                  <a:off x="10607888" y="7448307"/>
                  <a:ext cx="1400145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 err="1"/>
                    <a:t>Malaccensis</a:t>
                  </a:r>
                  <a:r>
                    <a:rPr lang="en-US" sz="800" b="1" dirty="0"/>
                    <a:t> </a:t>
                  </a:r>
                  <a:r>
                    <a:rPr lang="en-US" sz="800" b="1" dirty="0" err="1"/>
                    <a:t>nain</a:t>
                  </a:r>
                  <a:endParaRPr lang="en-US" sz="800" b="1" dirty="0"/>
                </a:p>
                <a:p>
                  <a:pPr algn="ctr"/>
                  <a:r>
                    <a:rPr lang="en-US" sz="800" i="1" dirty="0"/>
                    <a:t>ssp. </a:t>
                  </a:r>
                  <a:r>
                    <a:rPr lang="en-US" sz="800" i="1" dirty="0" err="1"/>
                    <a:t>malaccensis</a:t>
                  </a:r>
                  <a:endParaRPr lang="en-US" sz="800" i="1" dirty="0"/>
                </a:p>
              </p:txBody>
            </p:sp>
            <p:sp>
              <p:nvSpPr>
                <p:cNvPr id="26" name="ZoneTexte 25"/>
                <p:cNvSpPr txBox="1"/>
                <p:nvPr/>
              </p:nvSpPr>
              <p:spPr>
                <a:xfrm>
                  <a:off x="10791159" y="8887462"/>
                  <a:ext cx="1008292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 err="1"/>
                    <a:t>Pisang</a:t>
                  </a:r>
                  <a:r>
                    <a:rPr lang="en-US" sz="800" b="1" dirty="0"/>
                    <a:t> </a:t>
                  </a:r>
                  <a:r>
                    <a:rPr lang="en-US" sz="800" b="1" dirty="0" err="1"/>
                    <a:t>Lilin</a:t>
                  </a:r>
                  <a:endParaRPr lang="en-US" sz="800" b="1" dirty="0"/>
                </a:p>
                <a:p>
                  <a:pPr algn="ctr"/>
                  <a:r>
                    <a:rPr lang="en-US" sz="800" i="1" dirty="0"/>
                    <a:t>hybrid</a:t>
                  </a:r>
                </a:p>
              </p:txBody>
            </p:sp>
            <p:sp>
              <p:nvSpPr>
                <p:cNvPr id="27" name="ZoneTexte 26"/>
                <p:cNvSpPr txBox="1"/>
                <p:nvPr/>
              </p:nvSpPr>
              <p:spPr>
                <a:xfrm>
                  <a:off x="6622138" y="8885215"/>
                  <a:ext cx="685490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 err="1"/>
                    <a:t>Paka</a:t>
                  </a:r>
                  <a:endParaRPr lang="en-US" sz="800" b="1" dirty="0"/>
                </a:p>
                <a:p>
                  <a:pPr algn="ctr"/>
                  <a:r>
                    <a:rPr lang="en-US" sz="800" i="1" dirty="0"/>
                    <a:t>hybrid</a:t>
                  </a:r>
                </a:p>
              </p:txBody>
            </p:sp>
            <p:sp>
              <p:nvSpPr>
                <p:cNvPr id="28" name="ZoneTexte 27"/>
                <p:cNvSpPr txBox="1"/>
                <p:nvPr/>
              </p:nvSpPr>
              <p:spPr>
                <a:xfrm>
                  <a:off x="6418052" y="7450779"/>
                  <a:ext cx="1121846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 err="1"/>
                    <a:t>Pisang</a:t>
                  </a:r>
                  <a:r>
                    <a:rPr lang="en-US" sz="800" b="1" dirty="0"/>
                    <a:t> </a:t>
                  </a:r>
                  <a:r>
                    <a:rPr lang="en-US" sz="800" b="1" dirty="0" err="1"/>
                    <a:t>Madu</a:t>
                  </a:r>
                  <a:endParaRPr lang="en-US" sz="800" b="1" dirty="0"/>
                </a:p>
                <a:p>
                  <a:pPr algn="ctr"/>
                  <a:r>
                    <a:rPr lang="en-US" sz="800" i="1" dirty="0"/>
                    <a:t>hybrid</a:t>
                  </a:r>
                </a:p>
              </p:txBody>
            </p:sp>
            <p:sp>
              <p:nvSpPr>
                <p:cNvPr id="29" name="ZoneTexte 28"/>
                <p:cNvSpPr txBox="1"/>
                <p:nvPr/>
              </p:nvSpPr>
              <p:spPr>
                <a:xfrm>
                  <a:off x="10646284" y="5994207"/>
                  <a:ext cx="1318051" cy="4917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/>
                    <a:t>DH Pahang</a:t>
                  </a:r>
                </a:p>
                <a:p>
                  <a:pPr algn="ctr"/>
                  <a:r>
                    <a:rPr lang="en-US" sz="800" i="1" dirty="0"/>
                    <a:t>ssp. </a:t>
                  </a:r>
                  <a:r>
                    <a:rPr lang="en-US" sz="800" i="1" dirty="0" err="1"/>
                    <a:t>malaccensis</a:t>
                  </a:r>
                  <a:endParaRPr lang="en-US" sz="800" i="1" dirty="0"/>
                </a:p>
              </p:txBody>
            </p:sp>
          </p:grpSp>
        </p:grpSp>
        <p:grpSp>
          <p:nvGrpSpPr>
            <p:cNvPr id="64" name="Groupe 63"/>
            <p:cNvGrpSpPr/>
            <p:nvPr/>
          </p:nvGrpSpPr>
          <p:grpSpPr>
            <a:xfrm>
              <a:off x="0" y="337591"/>
              <a:ext cx="4332319" cy="5352415"/>
              <a:chOff x="9200956" y="25317"/>
              <a:chExt cx="4332319" cy="5352415"/>
            </a:xfrm>
          </p:grpSpPr>
          <p:grpSp>
            <p:nvGrpSpPr>
              <p:cNvPr id="34" name="Groupe 33"/>
              <p:cNvGrpSpPr/>
              <p:nvPr/>
            </p:nvGrpSpPr>
            <p:grpSpPr>
              <a:xfrm>
                <a:off x="11356991" y="25317"/>
                <a:ext cx="2166074" cy="2167638"/>
                <a:chOff x="3095762" y="7115947"/>
                <a:chExt cx="2880000" cy="2882080"/>
              </a:xfrm>
            </p:grpSpPr>
            <p:pic>
              <p:nvPicPr>
                <p:cNvPr id="35" name="Image 34"/>
                <p:cNvPicPr>
                  <a:picLocks noChangeAspect="1"/>
                </p:cNvPicPr>
                <p:nvPr/>
              </p:nvPicPr>
              <p:blipFill>
                <a:blip r:embed="rId16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095762" y="7118027"/>
                  <a:ext cx="2880000" cy="2880000"/>
                </a:xfrm>
                <a:prstGeom prst="rect">
                  <a:avLst/>
                </a:prstGeom>
              </p:spPr>
            </p:pic>
            <p:sp>
              <p:nvSpPr>
                <p:cNvPr id="36" name="ZoneTexte 35"/>
                <p:cNvSpPr txBox="1"/>
                <p:nvPr/>
              </p:nvSpPr>
              <p:spPr>
                <a:xfrm>
                  <a:off x="4111404" y="7115947"/>
                  <a:ext cx="819622" cy="4859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/>
                    <a:t>Manang</a:t>
                  </a:r>
                </a:p>
                <a:p>
                  <a:pPr algn="ctr"/>
                  <a:r>
                    <a:rPr lang="en-US" sz="800" i="1" dirty="0"/>
                    <a:t>hybrid</a:t>
                  </a:r>
                </a:p>
              </p:txBody>
            </p:sp>
          </p:grpSp>
          <p:grpSp>
            <p:nvGrpSpPr>
              <p:cNvPr id="37" name="Groupe 36"/>
              <p:cNvGrpSpPr/>
              <p:nvPr/>
            </p:nvGrpSpPr>
            <p:grpSpPr>
              <a:xfrm>
                <a:off x="9206061" y="25317"/>
                <a:ext cx="2166074" cy="2167638"/>
                <a:chOff x="235897" y="7115947"/>
                <a:chExt cx="2880000" cy="2882080"/>
              </a:xfrm>
            </p:grpSpPr>
            <p:pic>
              <p:nvPicPr>
                <p:cNvPr id="38" name="Image 37"/>
                <p:cNvPicPr>
                  <a:picLocks noChangeAspect="1"/>
                </p:cNvPicPr>
                <p:nvPr/>
              </p:nvPicPr>
              <p:blipFill>
                <a:blip r:embed="rId17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5897" y="7118027"/>
                  <a:ext cx="2880000" cy="2880000"/>
                </a:xfrm>
                <a:prstGeom prst="rect">
                  <a:avLst/>
                </a:prstGeom>
              </p:spPr>
            </p:pic>
            <p:sp>
              <p:nvSpPr>
                <p:cNvPr id="39" name="ZoneTexte 38"/>
                <p:cNvSpPr txBox="1"/>
                <p:nvPr/>
              </p:nvSpPr>
              <p:spPr>
                <a:xfrm>
                  <a:off x="892585" y="7115947"/>
                  <a:ext cx="1587093" cy="4859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/>
                    <a:t>Calcutta4</a:t>
                  </a:r>
                </a:p>
                <a:p>
                  <a:pPr algn="ctr"/>
                  <a:r>
                    <a:rPr lang="en-US" sz="800" i="1" dirty="0"/>
                    <a:t>ssp. </a:t>
                  </a:r>
                  <a:r>
                    <a:rPr lang="en-US" sz="800" i="1" dirty="0" err="1"/>
                    <a:t>burmannicoides</a:t>
                  </a:r>
                  <a:endParaRPr lang="en-US" sz="800" i="1" dirty="0"/>
                </a:p>
              </p:txBody>
            </p:sp>
          </p:grpSp>
          <p:pic>
            <p:nvPicPr>
              <p:cNvPr id="40" name="Image 39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200956" y="3215383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41" name="Image 40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2450238" y="4294695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42" name="Image 41"/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200956" y="4294695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43" name="Image 42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2447771" y="2131166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44" name="Image 43"/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2447771" y="3215383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45" name="Image 44"/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369668" y="2131166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46" name="Image 45"/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369668" y="4294695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47" name="Image 46"/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369668" y="3215383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48" name="Image 47"/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280292" y="2131166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49" name="Image 48"/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280292" y="4294695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50" name="Image 49"/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280292" y="3215383"/>
                <a:ext cx="1083037" cy="1083037"/>
              </a:xfrm>
              <a:prstGeom prst="rect">
                <a:avLst/>
              </a:prstGeom>
            </p:spPr>
          </p:pic>
          <p:pic>
            <p:nvPicPr>
              <p:cNvPr id="51" name="Image 50"/>
              <p:cNvPicPr>
                <a:picLocks noChangeAspect="1"/>
              </p:cNvPicPr>
              <p:nvPr/>
            </p:nvPicPr>
            <p:blipFill>
              <a:blip r:embed="rId2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200956" y="2131166"/>
                <a:ext cx="1083037" cy="1083037"/>
              </a:xfrm>
              <a:prstGeom prst="rect">
                <a:avLst/>
              </a:prstGeom>
            </p:spPr>
          </p:pic>
          <p:sp>
            <p:nvSpPr>
              <p:cNvPr id="52" name="ZoneTexte 51"/>
              <p:cNvSpPr txBox="1"/>
              <p:nvPr/>
            </p:nvSpPr>
            <p:spPr>
              <a:xfrm>
                <a:off x="9236633" y="1991088"/>
                <a:ext cx="1015576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err="1"/>
                  <a:t>Akondro</a:t>
                </a:r>
                <a:r>
                  <a:rPr lang="en-US" sz="800" b="1" dirty="0"/>
                  <a:t> </a:t>
                </a:r>
                <a:r>
                  <a:rPr lang="en-US" sz="800" b="1" dirty="0" err="1"/>
                  <a:t>Mainty</a:t>
                </a:r>
                <a:endParaRPr lang="en-US" sz="800" b="1" dirty="0"/>
              </a:p>
              <a:p>
                <a:pPr algn="ctr"/>
                <a:r>
                  <a:rPr lang="en-US" sz="800" i="1" dirty="0"/>
                  <a:t>hybrid</a:t>
                </a:r>
              </a:p>
            </p:txBody>
          </p:sp>
          <p:sp>
            <p:nvSpPr>
              <p:cNvPr id="53" name="ZoneTexte 52"/>
              <p:cNvSpPr txBox="1"/>
              <p:nvPr/>
            </p:nvSpPr>
            <p:spPr>
              <a:xfrm>
                <a:off x="10435153" y="3080777"/>
                <a:ext cx="760751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err="1"/>
                  <a:t>Banksii</a:t>
                </a:r>
                <a:endParaRPr lang="en-US" sz="800" b="1" dirty="0"/>
              </a:p>
              <a:p>
                <a:pPr algn="ctr"/>
                <a:r>
                  <a:rPr lang="en-US" sz="800" i="1" dirty="0"/>
                  <a:t>ssp. </a:t>
                </a:r>
                <a:r>
                  <a:rPr lang="en-US" sz="800" i="1" dirty="0" err="1"/>
                  <a:t>banksii</a:t>
                </a:r>
                <a:endParaRPr lang="en-US" sz="800" i="1" dirty="0"/>
              </a:p>
            </p:txBody>
          </p:sp>
          <p:sp>
            <p:nvSpPr>
              <p:cNvPr id="54" name="ZoneTexte 53"/>
              <p:cNvSpPr txBox="1"/>
              <p:nvPr/>
            </p:nvSpPr>
            <p:spPr>
              <a:xfrm>
                <a:off x="10337374" y="4146393"/>
                <a:ext cx="969808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/>
                  <a:t>Borneo</a:t>
                </a:r>
              </a:p>
              <a:p>
                <a:pPr algn="ctr"/>
                <a:r>
                  <a:rPr lang="en-US" sz="800" i="1" dirty="0"/>
                  <a:t>ssp. </a:t>
                </a:r>
                <a:r>
                  <a:rPr lang="en-US" sz="800" i="1" dirty="0" err="1"/>
                  <a:t>microcarpa</a:t>
                </a:r>
                <a:endParaRPr lang="en-US" sz="800" i="1" dirty="0"/>
              </a:p>
            </p:txBody>
          </p:sp>
          <p:sp>
            <p:nvSpPr>
              <p:cNvPr id="55" name="ZoneTexte 54"/>
              <p:cNvSpPr txBox="1"/>
              <p:nvPr/>
            </p:nvSpPr>
            <p:spPr>
              <a:xfrm>
                <a:off x="10552966" y="1991088"/>
                <a:ext cx="508855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err="1"/>
                  <a:t>Galeo</a:t>
                </a:r>
                <a:endParaRPr lang="en-US" sz="800" b="1" dirty="0"/>
              </a:p>
              <a:p>
                <a:pPr algn="ctr"/>
                <a:r>
                  <a:rPr lang="en-US" sz="800" i="1" dirty="0"/>
                  <a:t>hybrid</a:t>
                </a:r>
              </a:p>
            </p:txBody>
          </p:sp>
          <p:sp>
            <p:nvSpPr>
              <p:cNvPr id="56" name="ZoneTexte 55"/>
              <p:cNvSpPr txBox="1"/>
              <p:nvPr/>
            </p:nvSpPr>
            <p:spPr>
              <a:xfrm>
                <a:off x="11470620" y="3080777"/>
                <a:ext cx="876012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/>
                  <a:t>Grande </a:t>
                </a:r>
                <a:r>
                  <a:rPr lang="en-US" sz="800" b="1" dirty="0" err="1"/>
                  <a:t>Naine</a:t>
                </a:r>
                <a:endParaRPr lang="en-US" sz="800" b="1" dirty="0"/>
              </a:p>
              <a:p>
                <a:pPr algn="ctr"/>
                <a:r>
                  <a:rPr lang="en-US" sz="800" i="1" dirty="0"/>
                  <a:t>triploid hybrid</a:t>
                </a:r>
              </a:p>
            </p:txBody>
          </p:sp>
          <p:sp>
            <p:nvSpPr>
              <p:cNvPr id="57" name="ZoneTexte 56"/>
              <p:cNvSpPr txBox="1"/>
              <p:nvPr/>
            </p:nvSpPr>
            <p:spPr>
              <a:xfrm>
                <a:off x="11615563" y="4146393"/>
                <a:ext cx="566108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/>
                  <a:t>IDN110</a:t>
                </a:r>
              </a:p>
              <a:p>
                <a:pPr algn="ctr"/>
                <a:r>
                  <a:rPr lang="en-US" sz="800" i="1" dirty="0"/>
                  <a:t>hybrid</a:t>
                </a:r>
              </a:p>
            </p:txBody>
          </p:sp>
          <p:sp>
            <p:nvSpPr>
              <p:cNvPr id="58" name="ZoneTexte 57"/>
              <p:cNvSpPr txBox="1"/>
              <p:nvPr/>
            </p:nvSpPr>
            <p:spPr>
              <a:xfrm>
                <a:off x="11516741" y="1991088"/>
                <a:ext cx="777401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/>
                  <a:t>Maia </a:t>
                </a:r>
                <a:r>
                  <a:rPr lang="en-US" sz="800" b="1" dirty="0" err="1"/>
                  <a:t>Oa</a:t>
                </a:r>
                <a:endParaRPr lang="en-US" sz="800" b="1" dirty="0"/>
              </a:p>
              <a:p>
                <a:pPr algn="ctr"/>
                <a:r>
                  <a:rPr lang="en-US" sz="800" i="1" dirty="0"/>
                  <a:t>ssp. </a:t>
                </a:r>
                <a:r>
                  <a:rPr lang="en-US" sz="800" i="1" dirty="0" err="1"/>
                  <a:t>zebrina</a:t>
                </a:r>
                <a:endParaRPr lang="en-US" sz="800" i="1" dirty="0"/>
              </a:p>
            </p:txBody>
          </p:sp>
          <p:sp>
            <p:nvSpPr>
              <p:cNvPr id="59" name="ZoneTexte 58"/>
              <p:cNvSpPr txBox="1"/>
              <p:nvPr/>
            </p:nvSpPr>
            <p:spPr>
              <a:xfrm>
                <a:off x="12467407" y="3080777"/>
                <a:ext cx="1053061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err="1"/>
                  <a:t>Malaccensis</a:t>
                </a:r>
                <a:r>
                  <a:rPr lang="en-US" sz="800" b="1" dirty="0"/>
                  <a:t> </a:t>
                </a:r>
                <a:r>
                  <a:rPr lang="en-US" sz="800" b="1" dirty="0" err="1"/>
                  <a:t>nain</a:t>
                </a:r>
                <a:endParaRPr lang="en-US" sz="800" b="1" dirty="0"/>
              </a:p>
              <a:p>
                <a:pPr algn="ctr"/>
                <a:r>
                  <a:rPr lang="en-US" sz="800" i="1" dirty="0"/>
                  <a:t>ssp. </a:t>
                </a:r>
                <a:r>
                  <a:rPr lang="en-US" sz="800" i="1" dirty="0" err="1"/>
                  <a:t>malaccensis</a:t>
                </a:r>
                <a:endParaRPr lang="en-US" sz="800" i="1" dirty="0"/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>
                <a:off x="12605245" y="4146393"/>
                <a:ext cx="758345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err="1"/>
                  <a:t>Pisang</a:t>
                </a:r>
                <a:r>
                  <a:rPr lang="en-US" sz="800" b="1" dirty="0"/>
                  <a:t> </a:t>
                </a:r>
                <a:r>
                  <a:rPr lang="en-US" sz="800" b="1" dirty="0" err="1"/>
                  <a:t>Lilin</a:t>
                </a:r>
                <a:endParaRPr lang="en-US" sz="800" b="1" dirty="0"/>
              </a:p>
              <a:p>
                <a:pPr algn="ctr"/>
                <a:r>
                  <a:rPr lang="en-US" sz="800" i="1" dirty="0"/>
                  <a:t>hybrid</a:t>
                </a:r>
              </a:p>
            </p:txBody>
          </p:sp>
          <p:sp>
            <p:nvSpPr>
              <p:cNvPr id="61" name="ZoneTexte 60"/>
              <p:cNvSpPr txBox="1"/>
              <p:nvPr/>
            </p:nvSpPr>
            <p:spPr>
              <a:xfrm>
                <a:off x="9470492" y="4146393"/>
                <a:ext cx="515563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err="1"/>
                  <a:t>Paka</a:t>
                </a:r>
                <a:endParaRPr lang="en-US" sz="800" b="1" dirty="0"/>
              </a:p>
              <a:p>
                <a:pPr algn="ctr"/>
                <a:r>
                  <a:rPr lang="en-US" sz="800" i="1" dirty="0"/>
                  <a:t>hybrid</a:t>
                </a:r>
              </a:p>
            </p:txBody>
          </p:sp>
          <p:sp>
            <p:nvSpPr>
              <p:cNvPr id="62" name="ZoneTexte 61"/>
              <p:cNvSpPr txBox="1"/>
              <p:nvPr/>
            </p:nvSpPr>
            <p:spPr>
              <a:xfrm>
                <a:off x="9316997" y="3080777"/>
                <a:ext cx="843751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err="1"/>
                  <a:t>Pisang</a:t>
                </a:r>
                <a:r>
                  <a:rPr lang="en-US" sz="800" b="1" dirty="0"/>
                  <a:t> </a:t>
                </a:r>
                <a:r>
                  <a:rPr lang="en-US" sz="800" b="1" dirty="0" err="1"/>
                  <a:t>Madu</a:t>
                </a:r>
                <a:endParaRPr lang="en-US" sz="800" b="1" dirty="0"/>
              </a:p>
              <a:p>
                <a:pPr algn="ctr"/>
                <a:r>
                  <a:rPr lang="en-US" sz="800" i="1" dirty="0"/>
                  <a:t>hybrid</a:t>
                </a:r>
              </a:p>
            </p:txBody>
          </p:sp>
          <p:sp>
            <p:nvSpPr>
              <p:cNvPr id="63" name="ZoneTexte 62"/>
              <p:cNvSpPr txBox="1"/>
              <p:nvPr/>
            </p:nvSpPr>
            <p:spPr>
              <a:xfrm>
                <a:off x="12496281" y="1991088"/>
                <a:ext cx="991318" cy="365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/>
                  <a:t>DH Pahang</a:t>
                </a:r>
              </a:p>
              <a:p>
                <a:pPr algn="ctr"/>
                <a:r>
                  <a:rPr lang="en-US" sz="800" i="1" dirty="0"/>
                  <a:t>ssp. </a:t>
                </a:r>
                <a:r>
                  <a:rPr lang="en-US" sz="800" i="1" dirty="0" err="1"/>
                  <a:t>malaccensis</a:t>
                </a:r>
                <a:endParaRPr lang="en-US" sz="800" i="1" dirty="0"/>
              </a:p>
            </p:txBody>
          </p:sp>
        </p:grpSp>
      </p:grpSp>
      <p:sp>
        <p:nvSpPr>
          <p:cNvPr id="66" name="ZoneTexte 65"/>
          <p:cNvSpPr txBox="1"/>
          <p:nvPr/>
        </p:nvSpPr>
        <p:spPr>
          <a:xfrm>
            <a:off x="0" y="5493123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</a:t>
            </a:r>
            <a:r>
              <a:rPr lang="fr-FR" smtClean="0"/>
              <a:t>figure 3</a:t>
            </a:r>
            <a:endParaRPr lang="fr-FR" dirty="0"/>
          </a:p>
        </p:txBody>
      </p:sp>
      <p:sp>
        <p:nvSpPr>
          <p:cNvPr id="67" name="ZoneTexte 66"/>
          <p:cNvSpPr txBox="1"/>
          <p:nvPr/>
        </p:nvSpPr>
        <p:spPr>
          <a:xfrm>
            <a:off x="30175" y="3985"/>
            <a:ext cx="335196" cy="33519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b="1" dirty="0" smtClean="0"/>
              <a:t>A</a:t>
            </a:r>
            <a:endParaRPr lang="fr-FR" sz="1200" b="1" dirty="0"/>
          </a:p>
        </p:txBody>
      </p:sp>
      <p:sp>
        <p:nvSpPr>
          <p:cNvPr id="68" name="ZoneTexte 67"/>
          <p:cNvSpPr txBox="1"/>
          <p:nvPr/>
        </p:nvSpPr>
        <p:spPr>
          <a:xfrm>
            <a:off x="4291105" y="-17067"/>
            <a:ext cx="314509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b="1" dirty="0" smtClean="0"/>
              <a:t>B</a:t>
            </a:r>
            <a:endParaRPr lang="fr-FR" sz="1200" b="1" dirty="0"/>
          </a:p>
        </p:txBody>
      </p:sp>
      <p:sp>
        <p:nvSpPr>
          <p:cNvPr id="69" name="ZoneTexte 68"/>
          <p:cNvSpPr txBox="1"/>
          <p:nvPr/>
        </p:nvSpPr>
        <p:spPr>
          <a:xfrm>
            <a:off x="1697742" y="1140266"/>
            <a:ext cx="360996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defTabSz="457217"/>
            <a:r>
              <a:rPr lang="en-US" sz="600" kern="0" dirty="0" smtClean="0">
                <a:solidFill>
                  <a:prstClr val="black"/>
                </a:solidFill>
              </a:rPr>
              <a:t>chr02</a:t>
            </a:r>
            <a:endParaRPr lang="en-US" sz="600" kern="0" dirty="0">
              <a:solidFill>
                <a:prstClr val="black"/>
              </a:solidFill>
            </a:endParaRPr>
          </a:p>
        </p:txBody>
      </p:sp>
      <p:sp>
        <p:nvSpPr>
          <p:cNvPr id="70" name="ZoneTexte 69"/>
          <p:cNvSpPr txBox="1"/>
          <p:nvPr/>
        </p:nvSpPr>
        <p:spPr>
          <a:xfrm flipH="1">
            <a:off x="-42864" y="1330054"/>
            <a:ext cx="37185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defTabSz="457217"/>
            <a:r>
              <a:rPr lang="en-US" sz="600" kern="0" dirty="0" smtClean="0">
                <a:solidFill>
                  <a:prstClr val="black"/>
                </a:solidFill>
              </a:rPr>
              <a:t>chr08</a:t>
            </a:r>
            <a:endParaRPr lang="en-US" sz="500" kern="0" dirty="0">
              <a:solidFill>
                <a:prstClr val="black"/>
              </a:solidFill>
            </a:endParaRPr>
          </a:p>
        </p:txBody>
      </p:sp>
      <p:sp>
        <p:nvSpPr>
          <p:cNvPr id="71" name="ZoneTexte 70"/>
          <p:cNvSpPr txBox="1"/>
          <p:nvPr/>
        </p:nvSpPr>
        <p:spPr>
          <a:xfrm flipH="1">
            <a:off x="1960031" y="1350266"/>
            <a:ext cx="37185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defTabSz="457217"/>
            <a:r>
              <a:rPr lang="en-US" sz="600" kern="0" dirty="0" smtClean="0">
                <a:solidFill>
                  <a:prstClr val="black"/>
                </a:solidFill>
              </a:rPr>
              <a:t>chr08</a:t>
            </a:r>
            <a:endParaRPr lang="en-US" sz="500" kern="0" dirty="0">
              <a:solidFill>
                <a:prstClr val="black"/>
              </a:solidFill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3680174" y="1119027"/>
            <a:ext cx="360996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defTabSz="457217"/>
            <a:r>
              <a:rPr lang="en-US" sz="600" kern="0" dirty="0" smtClean="0">
                <a:solidFill>
                  <a:prstClr val="black"/>
                </a:solidFill>
              </a:rPr>
              <a:t>chr02</a:t>
            </a:r>
            <a:endParaRPr lang="en-US" sz="600" kern="0" dirty="0">
              <a:solidFill>
                <a:prstClr val="black"/>
              </a:solidFill>
            </a:endParaRPr>
          </a:p>
        </p:txBody>
      </p:sp>
      <p:sp>
        <p:nvSpPr>
          <p:cNvPr id="73" name="ZoneTexte 72"/>
          <p:cNvSpPr txBox="1"/>
          <p:nvPr/>
        </p:nvSpPr>
        <p:spPr>
          <a:xfrm flipH="1">
            <a:off x="4209439" y="1267301"/>
            <a:ext cx="37185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defTabSz="457217"/>
            <a:r>
              <a:rPr lang="en-US" sz="600" kern="0" dirty="0" smtClean="0">
                <a:solidFill>
                  <a:prstClr val="black"/>
                </a:solidFill>
              </a:rPr>
              <a:t>chr09</a:t>
            </a:r>
            <a:endParaRPr lang="en-US" sz="500" kern="0" dirty="0">
              <a:solidFill>
                <a:prstClr val="black"/>
              </a:solidFill>
            </a:endParaRPr>
          </a:p>
        </p:txBody>
      </p:sp>
      <p:sp>
        <p:nvSpPr>
          <p:cNvPr id="74" name="ZoneTexte 73"/>
          <p:cNvSpPr txBox="1"/>
          <p:nvPr/>
        </p:nvSpPr>
        <p:spPr>
          <a:xfrm>
            <a:off x="6101085" y="1176236"/>
            <a:ext cx="360996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defTabSz="457217"/>
            <a:r>
              <a:rPr lang="en-US" sz="600" kern="0" smtClean="0">
                <a:solidFill>
                  <a:prstClr val="black"/>
                </a:solidFill>
              </a:rPr>
              <a:t>chr01</a:t>
            </a:r>
            <a:endParaRPr lang="en-US" sz="600" kern="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12886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ésentation1" id="{73C8887B-0EB9-4F85-94F0-A6912946C4AE}" vid="{33BCC8B2-B507-434A-99DC-0B1A1E141DE8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figure_AnnalsOfBotany</Template>
  <TotalTime>25</TotalTime>
  <Words>106</Words>
  <Application>Microsoft Office PowerPoint</Application>
  <PresentationFormat>Personnalisé</PresentationFormat>
  <Paragraphs>6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upouy</dc:creator>
  <cp:lastModifiedBy>dupouy</cp:lastModifiedBy>
  <cp:revision>4</cp:revision>
  <dcterms:created xsi:type="dcterms:W3CDTF">2018-11-30T09:13:03Z</dcterms:created>
  <dcterms:modified xsi:type="dcterms:W3CDTF">2019-02-18T14:04:04Z</dcterms:modified>
</cp:coreProperties>
</file>